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2"/>
  </p:notesMasterIdLst>
  <p:sldIdLst>
    <p:sldId id="1095" r:id="rId2"/>
    <p:sldId id="1073" r:id="rId3"/>
    <p:sldId id="1084" r:id="rId4"/>
    <p:sldId id="1093" r:id="rId5"/>
    <p:sldId id="1094" r:id="rId6"/>
    <p:sldId id="1080" r:id="rId7"/>
    <p:sldId id="1090" r:id="rId8"/>
    <p:sldId id="1077" r:id="rId9"/>
    <p:sldId id="1058" r:id="rId10"/>
    <p:sldId id="1078" r:id="rId11"/>
  </p:sldIdLst>
  <p:sldSz cx="18288000" cy="10287000"/>
  <p:notesSz cx="6858000" cy="9144000"/>
  <p:embeddedFontLst>
    <p:embeddedFont>
      <p:font typeface="Assistant" pitchFamily="2" charset="-79"/>
      <p:regular r:id="rId13"/>
      <p:bold r:id="rId14"/>
    </p:embeddedFont>
    <p:embeddedFont>
      <p:font typeface="Assistant Bold" charset="-79"/>
      <p:regular r:id="rId15"/>
      <p:bold r:id="rId16"/>
    </p:embeddedFont>
    <p:embeddedFont>
      <p:font typeface="Assistant ExtraBold" pitchFamily="2" charset="-79"/>
      <p:bold r:id="rId17"/>
    </p:embeddedFont>
    <p:embeddedFont>
      <p:font typeface="Assistant Regular" charset="-79"/>
      <p:regular r:id="rId18"/>
    </p:embeddedFont>
    <p:embeddedFont>
      <p:font typeface="Assistant SemiBold" pitchFamily="2" charset="-79"/>
      <p:bold r:id="rId19"/>
    </p:embeddedFont>
    <p:embeddedFont>
      <p:font typeface="Calibri" panose="020F0502020204030204" pitchFamily="34" charset="0"/>
      <p:regular r:id="rId20"/>
      <p:bold r:id="rId21"/>
      <p:italic r:id="rId22"/>
      <p:boldItalic r:id="rId23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1.fntdata"/><Relationship Id="rId18" Type="http://schemas.openxmlformats.org/officeDocument/2006/relationships/font" Target="fonts/font6.fntdata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font" Target="fonts/font9.fntdata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font" Target="fonts/font5.fntdata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font" Target="fonts/font4.fntdata"/><Relationship Id="rId20" Type="http://schemas.openxmlformats.org/officeDocument/2006/relationships/font" Target="fonts/font8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font" Target="fonts/font3.fntdata"/><Relationship Id="rId23" Type="http://schemas.openxmlformats.org/officeDocument/2006/relationships/font" Target="fonts/font11.fntdata"/><Relationship Id="rId10" Type="http://schemas.openxmlformats.org/officeDocument/2006/relationships/slide" Target="slides/slide9.xml"/><Relationship Id="rId19" Type="http://schemas.openxmlformats.org/officeDocument/2006/relationships/font" Target="fonts/font7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2.fntdata"/><Relationship Id="rId22" Type="http://schemas.openxmlformats.org/officeDocument/2006/relationships/font" Target="fonts/font10.fntdata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922531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8348568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29987147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svg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356147"/>
            <a:chOff x="1573698" y="-152998"/>
            <a:chExt cx="7219847" cy="1987255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846660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10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Eating Out &amp; Eating Healthy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1,000 more steps than last week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660126"/>
            <a:ext cx="12316505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It can be hard to avoid foods you used to order at restaurants. Try going somewhere new OR set yourself up for success at Sweetgreen.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Ask friends and family to have healthy food for you in advance. Let them know about your goals </a:t>
            </a:r>
            <a:r>
              <a:rPr lang="en-US" sz="3000"/>
              <a:t>and success -- you </a:t>
            </a:r>
            <a:r>
              <a:rPr lang="en-US" sz="3000" dirty="0"/>
              <a:t>may inspire them!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use POSITIVITY to defeat NEGATIVE thought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s you increase your daily steps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supports your succes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1445624" cy="6001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Is being healthy an important part of who you are? (select one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very important to who I am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important to who I am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becoming important to who I am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good, but not who I am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not important to who I am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healthy is completely unimportant to me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Stack of citrus fruits cut in half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959227" y="3390899"/>
            <a:ext cx="5645847" cy="5645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Do you prioritize healthy choic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1445624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u="sng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ould you describe yourself as someone who PRIORITIZES healthy choices to support your lifestyle (Select one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ways, my health comes firs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ost of the tim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 fair amount of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 of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ess than half of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ccasionall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arel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ev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5" name="Picture 4" descr="Gold trophy">
            <a:extLst>
              <a:ext uri="{FF2B5EF4-FFF2-40B4-BE49-F238E27FC236}">
                <a16:creationId xmlns:a16="http://schemas.microsoft.com/office/drawing/2014/main" id="{558A8ECD-A6B5-4ABE-AAB2-F45D3147FF6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376312" y="3581524"/>
            <a:ext cx="4923392" cy="5979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7529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laces where you choose health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2207624" cy="6986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ere do you choose healthy food most, or all of the time (Select all)</a:t>
            </a: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the grocery stor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 my own hom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restauran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 At the home of a friend or family memb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part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sporting even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Holidays or special occasion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wor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Red apple on blue weighing scal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984640" y="3390900"/>
            <a:ext cx="6163001" cy="411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417499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re do we ea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24000" y="2881342"/>
            <a:ext cx="14601344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en a meal outside of the home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restaurant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 friend’s house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ere? (DISCUSS)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 Regular" charset="-79"/>
                <a:cs typeface="Assistant Regular" charset="-79"/>
              </a:rPr>
              <a:t>When eating out of the home, how do we track calories and fat grams?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s it harder or easier?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ny suggestions?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78818" y="8456366"/>
            <a:ext cx="15468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You </a:t>
            </a:r>
            <a:r>
              <a:rPr lang="en-US" sz="3200" b="1" dirty="0" err="1"/>
              <a:t>gotta</a:t>
            </a:r>
            <a:r>
              <a:rPr lang="en-US" sz="3200" b="1" dirty="0"/>
              <a:t> live your life!</a:t>
            </a:r>
          </a:p>
          <a:p>
            <a:r>
              <a:rPr lang="en-US" sz="2800" dirty="0"/>
              <a:t>This is a LIFESTYLE, not a diet, which means we have to make it work in all areas of life.  You </a:t>
            </a:r>
            <a:r>
              <a:rPr lang="en-US" sz="2800" dirty="0" err="1"/>
              <a:t>gotta</a:t>
            </a:r>
            <a:r>
              <a:rPr lang="en-US" sz="2800" dirty="0"/>
              <a:t> have fun, and that means being able to enjoy time with others and going to your favorite places.</a:t>
            </a:r>
          </a:p>
          <a:p>
            <a:endParaRPr lang="en-US" sz="2000" dirty="0"/>
          </a:p>
        </p:txBody>
      </p:sp>
      <p:pic>
        <p:nvPicPr>
          <p:cNvPr id="5" name="Graphic 4" descr="Cheers with solid fill">
            <a:extLst>
              <a:ext uri="{FF2B5EF4-FFF2-40B4-BE49-F238E27FC236}">
                <a16:creationId xmlns:a16="http://schemas.microsoft.com/office/drawing/2014/main" id="{E453062F-0802-4E53-B731-7167D3C0EE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31914" y="8642746"/>
            <a:ext cx="1449285" cy="14492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DCC4AC5-8CF7-4DC4-95B1-9572B6938029}"/>
              </a:ext>
            </a:extLst>
          </p:cNvPr>
          <p:cNvSpPr txBox="1"/>
          <p:nvPr/>
        </p:nvSpPr>
        <p:spPr>
          <a:xfrm>
            <a:off x="1479237" y="2273010"/>
            <a:ext cx="16001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Since starting the program, how many of us have:</a:t>
            </a:r>
          </a:p>
        </p:txBody>
      </p:sp>
      <p:pic>
        <p:nvPicPr>
          <p:cNvPr id="22" name="Picture 21" descr="Coffee cups and croissants with flowers">
            <a:extLst>
              <a:ext uri="{FF2B5EF4-FFF2-40B4-BE49-F238E27FC236}">
                <a16:creationId xmlns:a16="http://schemas.microsoft.com/office/drawing/2014/main" id="{40933439-A155-4E3D-99C4-0961FFC9385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1" b="1001"/>
          <a:stretch/>
        </p:blipFill>
        <p:spPr>
          <a:xfrm>
            <a:off x="13453568" y="1909531"/>
            <a:ext cx="4186287" cy="61524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Four Keys to Eating Out Health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24153" y="1281807"/>
            <a:ext cx="10479651" cy="8279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Plan Ahead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Restaurant websites, even menus, have nutrition info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Think about what you’ll order before you go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Don’t be afraid to ask for something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Request a modification, like a greens instead of rice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Its normal to modify dishes, they want you </a:t>
            </a:r>
            <a:r>
              <a:rPr lang="en-US" sz="2800">
                <a:latin typeface="Assistant Regular" charset="-79"/>
                <a:cs typeface="Assistant Regular" charset="-79"/>
              </a:rPr>
              <a:t>to enjoy!</a:t>
            </a:r>
            <a:endParaRPr lang="en-US" sz="2800" dirty="0">
              <a:latin typeface="Assistant Regular" charset="-79"/>
              <a:cs typeface="Assistant Regular" charset="-79"/>
            </a:endParaRP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Be firm and friendly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Take charge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Order first, don’t be tempted by others’ choices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Lead with positivity, be excited to be out and be healthy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Choose foods carefully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Ask how things are prepared to find hidden sugar and fat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Avoid those pesky food with things like “creamy” in the descriptions. 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Ask for sauce on the side to use less.</a:t>
            </a: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2" name="Picture 4" descr="Keys and house keychain suspended on hook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14"/>
          <a:stretch/>
        </p:blipFill>
        <p:spPr bwMode="auto">
          <a:xfrm>
            <a:off x="11658755" y="2729736"/>
            <a:ext cx="6114747" cy="4827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Open book outline">
            <a:extLst>
              <a:ext uri="{FF2B5EF4-FFF2-40B4-BE49-F238E27FC236}">
                <a16:creationId xmlns:a16="http://schemas.microsoft.com/office/drawing/2014/main" id="{C8523ECA-E98A-49C8-A136-C4E7E2D64A7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61325" y="8833341"/>
            <a:ext cx="1531577" cy="15315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4B90BA-C379-4186-95B4-8C2121703A8E}"/>
              </a:ext>
            </a:extLst>
          </p:cNvPr>
          <p:cNvSpPr txBox="1"/>
          <p:nvPr/>
        </p:nvSpPr>
        <p:spPr>
          <a:xfrm>
            <a:off x="2667000" y="9183632"/>
            <a:ext cx="13182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Pages 4-5 have more ideas about how to tell healthy from unhealthy foods at restaurants. Make sure to look at these before you eat out this week!</a:t>
            </a:r>
          </a:p>
        </p:txBody>
      </p:sp>
    </p:spTree>
    <p:extLst>
      <p:ext uri="{BB962C8B-B14F-4D97-AF65-F5344CB8AC3E}">
        <p14:creationId xmlns:p14="http://schemas.microsoft.com/office/powerpoint/2010/main" val="5959177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ractice Eating Out --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601811" y="3390900"/>
            <a:ext cx="8384008" cy="6100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4800" dirty="0"/>
              <a:t>Fast Food restaurant (page 6), 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4800" dirty="0"/>
              <a:t>Restaurant (page 7)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4800" dirty="0"/>
              <a:t>Banquets and Buffets (page 8)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4800" dirty="0"/>
              <a:t>With family &amp; friends (page 9)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US" sz="3600" dirty="0"/>
          </a:p>
          <a:p>
            <a:pPr lvl="1">
              <a:lnSpc>
                <a:spcPct val="150000"/>
              </a:lnSpc>
            </a:pPr>
            <a:endParaRPr lang="en-US" sz="3600" dirty="0"/>
          </a:p>
        </p:txBody>
      </p:sp>
      <p:pic>
        <p:nvPicPr>
          <p:cNvPr id="2050" name="Picture 2" descr="Close-up of several outdoor café tables and chairs in sunshine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125200" y="2933700"/>
            <a:ext cx="6459758" cy="42984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Eat Healthy Everywhere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150 min of exercise this week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lready at 150 minutes? Can you make it to 160 minutes? How about 175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Eat healthy outside of your own hom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a plan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ome with a story to tell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38234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Make healthy your real life</a:t>
            </a:r>
          </a:p>
          <a:p>
            <a:r>
              <a:rPr lang="en-US" sz="2800" dirty="0"/>
              <a:t>Its great to have short-term goals, they can be motivating. But we want to make healthy living A LIFESTYLE.  Think of ways to bring healthy into normal life, &amp; make new habits that stick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8</TotalTime>
  <Words>844</Words>
  <Application>Microsoft Office PowerPoint</Application>
  <PresentationFormat>Custom</PresentationFormat>
  <Paragraphs>150</Paragraphs>
  <Slides>10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9" baseType="lpstr">
      <vt:lpstr>Courier New</vt:lpstr>
      <vt:lpstr>Assistant SemiBold</vt:lpstr>
      <vt:lpstr>Assistant</vt:lpstr>
      <vt:lpstr>Assistant Bold</vt:lpstr>
      <vt:lpstr>Calibri</vt:lpstr>
      <vt:lpstr>Arial</vt:lpstr>
      <vt:lpstr>Assistant Regular</vt:lpstr>
      <vt:lpstr>Assistant Extra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09</cp:revision>
  <dcterms:created xsi:type="dcterms:W3CDTF">2006-08-16T00:00:00Z</dcterms:created>
  <dcterms:modified xsi:type="dcterms:W3CDTF">2023-11-03T20:55:40Z</dcterms:modified>
  <dc:identifier>DAE7nbwep5o</dc:identifier>
</cp:coreProperties>
</file>